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9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3265DB-4791-4AF3-B541-09A9DA8E7D60}" type="datetimeFigureOut">
              <a:rPr lang="en-US" smtClean="0"/>
              <a:pPr/>
              <a:t>22-Feb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4CE2AC-7C45-4C62-9D36-55336ACA92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75903575"/>
              </p:ext>
            </p:extLst>
          </p:nvPr>
        </p:nvGraphicFramePr>
        <p:xfrm>
          <a:off x="457200" y="1219200"/>
          <a:ext cx="8382000" cy="449579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1999"/>
                <a:gridCol w="6096000"/>
                <a:gridCol w="685801"/>
                <a:gridCol w="838200"/>
              </a:tblGrid>
              <a:tr h="473882"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Network number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Network details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Score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Focus molecules</a:t>
                      </a:r>
                      <a:endParaRPr lang="en-IN" sz="1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ncer,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reproductive system diseases, lipid metabolism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48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Gene expression, cell signaling,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small molecule biochemistry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cs typeface="Arial" pitchFamily="34" charset="0"/>
                        </a:rPr>
                        <a:t>34</a:t>
                      </a:r>
                      <a:endParaRPr lang="en-IN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3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ncer, cell to cell signaling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and interaction, embryonic development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ellular assembly and organization, cellular compromise, DNA replication, recombination and repair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rdiovascular system development and function, cell morphology, cellular function and maintenance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6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Endocrine system development and function, small molecule biochemistry, lipid metabolism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arbohydrate metabolism, molecular transport, small molecule biochemistry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5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73882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8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Cell cycle, renal and urological system development and function, connective</a:t>
                      </a:r>
                      <a:r>
                        <a:rPr lang="en-US" sz="1000" baseline="0" dirty="0" smtClean="0">
                          <a:latin typeface="Arial" pitchFamily="34" charset="0"/>
                          <a:cs typeface="Arial" pitchFamily="34" charset="0"/>
                        </a:rPr>
                        <a:t> tissue development and function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7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  <a:tr h="443504">
                <a:tc>
                  <a:txBody>
                    <a:bodyPr/>
                    <a:lstStyle/>
                    <a:p>
                      <a:pPr algn="ctr"/>
                      <a:r>
                        <a:rPr lang="en-US" sz="1000" smtClean="0">
                          <a:latin typeface="Arial" pitchFamily="34" charset="0"/>
                          <a:cs typeface="Arial" pitchFamily="34" charset="0"/>
                        </a:rPr>
                        <a:t>9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Gene expression, cardiovascular system development and function, cell to cell signaling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2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  <a:endParaRPr lang="en-IN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anchor="ctr"/>
                </a:tc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381000" y="838200"/>
            <a:ext cx="76915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Supplemental Table 3. Networks involved during E</a:t>
            </a:r>
            <a:r>
              <a:rPr lang="en-US" sz="1000" b="1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eprivation (D16, 96 h AI) using IPA software </a:t>
            </a:r>
            <a:endParaRPr lang="en-IN" sz="10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9</Words>
  <Application>Microsoft Office PowerPoint</Application>
  <PresentationFormat>On-screen Show (4:3)</PresentationFormat>
  <Paragraphs>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ii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uresh</dc:creator>
  <cp:lastModifiedBy>user</cp:lastModifiedBy>
  <cp:revision>2</cp:revision>
  <dcterms:created xsi:type="dcterms:W3CDTF">2016-02-22T05:06:40Z</dcterms:created>
  <dcterms:modified xsi:type="dcterms:W3CDTF">2016-02-22T10:32:38Z</dcterms:modified>
</cp:coreProperties>
</file>